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2939C8E-67D0-834D-AE47-4396E360C280}" v="6" dt="2024-10-23T11:55:45.32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iara Napoletano" userId="3382be66-87d3-4f88-8936-a80a8def1550" providerId="ADAL" clId="{22939C8E-67D0-834D-AE47-4396E360C280}"/>
    <pc:docChg chg="undo custSel addSld delSld modSld">
      <pc:chgData name="Chiara Napoletano" userId="3382be66-87d3-4f88-8936-a80a8def1550" providerId="ADAL" clId="{22939C8E-67D0-834D-AE47-4396E360C280}" dt="2024-10-24T12:16:51.412" v="405" actId="20577"/>
      <pc:docMkLst>
        <pc:docMk/>
      </pc:docMkLst>
      <pc:sldChg chg="addSp delSp modSp mod">
        <pc:chgData name="Chiara Napoletano" userId="3382be66-87d3-4f88-8936-a80a8def1550" providerId="ADAL" clId="{22939C8E-67D0-834D-AE47-4396E360C280}" dt="2024-10-22T08:23:35.351" v="38" actId="1076"/>
        <pc:sldMkLst>
          <pc:docMk/>
          <pc:sldMk cId="34110016" sldId="256"/>
        </pc:sldMkLst>
        <pc:spChg chg="mod">
          <ac:chgData name="Chiara Napoletano" userId="3382be66-87d3-4f88-8936-a80a8def1550" providerId="ADAL" clId="{22939C8E-67D0-834D-AE47-4396E360C280}" dt="2024-10-21T08:27:11.666" v="28" actId="20577"/>
          <ac:spMkLst>
            <pc:docMk/>
            <pc:sldMk cId="34110016" sldId="256"/>
            <ac:spMk id="8" creationId="{FD5D694E-6B32-5C4C-0615-A949A503807B}"/>
          </ac:spMkLst>
        </pc:spChg>
        <pc:picChg chg="add mod">
          <ac:chgData name="Chiara Napoletano" userId="3382be66-87d3-4f88-8936-a80a8def1550" providerId="ADAL" clId="{22939C8E-67D0-834D-AE47-4396E360C280}" dt="2024-10-22T08:23:35.351" v="38" actId="1076"/>
          <ac:picMkLst>
            <pc:docMk/>
            <pc:sldMk cId="34110016" sldId="256"/>
            <ac:picMk id="3" creationId="{AD67C749-FD70-2C20-64D9-F71D9ACAC5EB}"/>
          </ac:picMkLst>
        </pc:picChg>
        <pc:picChg chg="add mod">
          <ac:chgData name="Chiara Napoletano" userId="3382be66-87d3-4f88-8936-a80a8def1550" providerId="ADAL" clId="{22939C8E-67D0-834D-AE47-4396E360C280}" dt="2024-10-22T08:23:31.117" v="37" actId="1076"/>
          <ac:picMkLst>
            <pc:docMk/>
            <pc:sldMk cId="34110016" sldId="256"/>
            <ac:picMk id="5" creationId="{C948334E-D710-356B-DE38-92EEE5A5DE1E}"/>
          </ac:picMkLst>
        </pc:picChg>
        <pc:picChg chg="del mod">
          <ac:chgData name="Chiara Napoletano" userId="3382be66-87d3-4f88-8936-a80a8def1550" providerId="ADAL" clId="{22939C8E-67D0-834D-AE47-4396E360C280}" dt="2024-10-22T08:23:01.058" v="33" actId="478"/>
          <ac:picMkLst>
            <pc:docMk/>
            <pc:sldMk cId="34110016" sldId="256"/>
            <ac:picMk id="10" creationId="{868C8F02-F347-CA25-32D6-ED2765F53456}"/>
          </ac:picMkLst>
        </pc:picChg>
        <pc:picChg chg="del mod">
          <ac:chgData name="Chiara Napoletano" userId="3382be66-87d3-4f88-8936-a80a8def1550" providerId="ADAL" clId="{22939C8E-67D0-834D-AE47-4396E360C280}" dt="2024-10-22T08:23:01.665" v="34" actId="478"/>
          <ac:picMkLst>
            <pc:docMk/>
            <pc:sldMk cId="34110016" sldId="256"/>
            <ac:picMk id="12" creationId="{C7F2978C-0ECC-EBCD-17E2-3FE51AAD6AB7}"/>
          </ac:picMkLst>
        </pc:picChg>
      </pc:sldChg>
      <pc:sldChg chg="addSp delSp modSp new mod">
        <pc:chgData name="Chiara Napoletano" userId="3382be66-87d3-4f88-8936-a80a8def1550" providerId="ADAL" clId="{22939C8E-67D0-834D-AE47-4396E360C280}" dt="2024-10-24T12:16:51.412" v="405" actId="20577"/>
        <pc:sldMkLst>
          <pc:docMk/>
          <pc:sldMk cId="1356691100" sldId="257"/>
        </pc:sldMkLst>
        <pc:spChg chg="del">
          <ac:chgData name="Chiara Napoletano" userId="3382be66-87d3-4f88-8936-a80a8def1550" providerId="ADAL" clId="{22939C8E-67D0-834D-AE47-4396E360C280}" dt="2024-10-23T11:51:14.816" v="40" actId="478"/>
          <ac:spMkLst>
            <pc:docMk/>
            <pc:sldMk cId="1356691100" sldId="257"/>
            <ac:spMk id="2" creationId="{D92A8919-27E2-4EFC-94C9-FC77FD0C120B}"/>
          </ac:spMkLst>
        </pc:spChg>
        <pc:spChg chg="del">
          <ac:chgData name="Chiara Napoletano" userId="3382be66-87d3-4f88-8936-a80a8def1550" providerId="ADAL" clId="{22939C8E-67D0-834D-AE47-4396E360C280}" dt="2024-10-23T11:51:16.080" v="41" actId="478"/>
          <ac:spMkLst>
            <pc:docMk/>
            <pc:sldMk cId="1356691100" sldId="257"/>
            <ac:spMk id="3" creationId="{66F8BE3E-8C66-06D5-D3B9-4715576B55B6}"/>
          </ac:spMkLst>
        </pc:spChg>
        <pc:spChg chg="add del mod">
          <ac:chgData name="Chiara Napoletano" userId="3382be66-87d3-4f88-8936-a80a8def1550" providerId="ADAL" clId="{22939C8E-67D0-834D-AE47-4396E360C280}" dt="2024-10-23T11:54:41.695" v="43" actId="478"/>
          <ac:spMkLst>
            <pc:docMk/>
            <pc:sldMk cId="1356691100" sldId="257"/>
            <ac:spMk id="11" creationId="{ECF152DA-9C56-1DAE-B6EF-69BE71522E53}"/>
          </ac:spMkLst>
        </pc:spChg>
        <pc:spChg chg="add del mod">
          <ac:chgData name="Chiara Napoletano" userId="3382be66-87d3-4f88-8936-a80a8def1550" providerId="ADAL" clId="{22939C8E-67D0-834D-AE47-4396E360C280}" dt="2024-10-23T11:54:41.695" v="43" actId="478"/>
          <ac:spMkLst>
            <pc:docMk/>
            <pc:sldMk cId="1356691100" sldId="257"/>
            <ac:spMk id="19" creationId="{40EF2CF3-C757-67F7-DD9E-DF5BC3080346}"/>
          </ac:spMkLst>
        </pc:spChg>
        <pc:spChg chg="add del mod">
          <ac:chgData name="Chiara Napoletano" userId="3382be66-87d3-4f88-8936-a80a8def1550" providerId="ADAL" clId="{22939C8E-67D0-834D-AE47-4396E360C280}" dt="2024-10-23T11:54:41.695" v="43" actId="478"/>
          <ac:spMkLst>
            <pc:docMk/>
            <pc:sldMk cId="1356691100" sldId="257"/>
            <ac:spMk id="20" creationId="{FFB9ECB8-1954-34B4-EAAA-3DEC7E60C2F3}"/>
          </ac:spMkLst>
        </pc:spChg>
        <pc:spChg chg="add del mod">
          <ac:chgData name="Chiara Napoletano" userId="3382be66-87d3-4f88-8936-a80a8def1550" providerId="ADAL" clId="{22939C8E-67D0-834D-AE47-4396E360C280}" dt="2024-10-23T11:54:41.695" v="43" actId="478"/>
          <ac:spMkLst>
            <pc:docMk/>
            <pc:sldMk cId="1356691100" sldId="257"/>
            <ac:spMk id="34" creationId="{6E05A95C-A64A-AEBA-3C2B-0DC483475BE8}"/>
          </ac:spMkLst>
        </pc:spChg>
        <pc:spChg chg="add mod">
          <ac:chgData name="Chiara Napoletano" userId="3382be66-87d3-4f88-8936-a80a8def1550" providerId="ADAL" clId="{22939C8E-67D0-834D-AE47-4396E360C280}" dt="2024-10-23T11:54:42.920" v="44"/>
          <ac:spMkLst>
            <pc:docMk/>
            <pc:sldMk cId="1356691100" sldId="257"/>
            <ac:spMk id="42" creationId="{DF28EC33-8D9B-36FB-A14C-66C3F1D91F22}"/>
          </ac:spMkLst>
        </pc:spChg>
        <pc:spChg chg="add mod">
          <ac:chgData name="Chiara Napoletano" userId="3382be66-87d3-4f88-8936-a80a8def1550" providerId="ADAL" clId="{22939C8E-67D0-834D-AE47-4396E360C280}" dt="2024-10-23T11:54:42.920" v="44"/>
          <ac:spMkLst>
            <pc:docMk/>
            <pc:sldMk cId="1356691100" sldId="257"/>
            <ac:spMk id="50" creationId="{94908E38-A432-FB11-0070-F7B10EF04B0D}"/>
          </ac:spMkLst>
        </pc:spChg>
        <pc:spChg chg="add mod">
          <ac:chgData name="Chiara Napoletano" userId="3382be66-87d3-4f88-8936-a80a8def1550" providerId="ADAL" clId="{22939C8E-67D0-834D-AE47-4396E360C280}" dt="2024-10-23T11:54:42.920" v="44"/>
          <ac:spMkLst>
            <pc:docMk/>
            <pc:sldMk cId="1356691100" sldId="257"/>
            <ac:spMk id="51" creationId="{C336DF86-F080-EC8F-D452-BA33BF8F8F03}"/>
          </ac:spMkLst>
        </pc:spChg>
        <pc:spChg chg="add mod">
          <ac:chgData name="Chiara Napoletano" userId="3382be66-87d3-4f88-8936-a80a8def1550" providerId="ADAL" clId="{22939C8E-67D0-834D-AE47-4396E360C280}" dt="2024-10-23T11:54:42.920" v="44"/>
          <ac:spMkLst>
            <pc:docMk/>
            <pc:sldMk cId="1356691100" sldId="257"/>
            <ac:spMk id="65" creationId="{0F80D3FA-0E68-0F64-0458-98BD87AA15D0}"/>
          </ac:spMkLst>
        </pc:spChg>
        <pc:spChg chg="add del mod">
          <ac:chgData name="Chiara Napoletano" userId="3382be66-87d3-4f88-8936-a80a8def1550" providerId="ADAL" clId="{22939C8E-67D0-834D-AE47-4396E360C280}" dt="2024-10-23T11:55:43.102" v="47"/>
          <ac:spMkLst>
            <pc:docMk/>
            <pc:sldMk cId="1356691100" sldId="257"/>
            <ac:spMk id="72" creationId="{CFC3EDB9-9B56-5352-7529-BC1ABF98A0B2}"/>
          </ac:spMkLst>
        </pc:spChg>
        <pc:spChg chg="add mod">
          <ac:chgData name="Chiara Napoletano" userId="3382be66-87d3-4f88-8936-a80a8def1550" providerId="ADAL" clId="{22939C8E-67D0-834D-AE47-4396E360C280}" dt="2024-10-24T12:16:51.412" v="405" actId="20577"/>
          <ac:spMkLst>
            <pc:docMk/>
            <pc:sldMk cId="1356691100" sldId="257"/>
            <ac:spMk id="73" creationId="{583A0904-A723-369E-DE80-BEC69EB50B7D}"/>
          </ac:spMkLst>
        </pc:sp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2" creationId="{4F74472A-002F-D6D6-E551-FCFFB0519443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3" creationId="{48821922-C11B-EB3C-04AB-ADF69C7C8D9E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4" creationId="{6192C783-0905-6F96-53E5-CED148C1B70D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5" creationId="{591D5EB2-40B8-5981-567B-45DD173C6654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6" creationId="{DA644901-5129-01F2-FB01-5A0ED374F5F2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7" creationId="{2DCCD9DC-AC60-F684-3704-C51FCD652E7F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8" creationId="{0E5CEEB8-7ABE-9F72-89AD-612F70FBE205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12" creationId="{6C79EC5A-DF55-7A2D-3A8A-68BC550390B8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13" creationId="{2AE52034-1B55-E0B3-E309-B8D27EBB0D5A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14" creationId="{EFF53E3F-54C3-232F-35E8-D20A331038F4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15" creationId="{B19A1604-920C-ED4E-6490-19A14CF08EEE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21" creationId="{C64263B2-D34D-AB7C-0195-A2153E1EA9C4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22" creationId="{B0F3D49C-6EBC-924C-A5F8-A10D7E57C33B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23" creationId="{FA5A0124-947B-BFAF-8BD6-6B86A45D7F36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24" creationId="{1194790A-9BB0-172A-B47C-F22D00D92604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25" creationId="{A5DFE59A-FFE7-F311-7853-95AA9D255ECB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26" creationId="{3AE931D5-A7BA-FAF8-21DC-076CFA79202A}"/>
          </ac:picMkLst>
        </pc:picChg>
        <pc:picChg chg="add del mod">
          <ac:chgData name="Chiara Napoletano" userId="3382be66-87d3-4f88-8936-a80a8def1550" providerId="ADAL" clId="{22939C8E-67D0-834D-AE47-4396E360C280}" dt="2024-10-23T11:54:41.695" v="43" actId="478"/>
          <ac:picMkLst>
            <pc:docMk/>
            <pc:sldMk cId="1356691100" sldId="257"/>
            <ac:picMk id="35" creationId="{26AC70F5-786C-1A80-F23D-8C8284830DE1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37" creationId="{35FA0C6D-F0C1-6AA8-300F-D7DFB9D294D6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38" creationId="{F436D54D-A023-BE17-7654-49853C5EDE84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39" creationId="{C7EF56DF-144C-E418-63F1-4EF61879371B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43" creationId="{6D9032C3-75BD-2F09-BD9D-C1A48FDA4783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44" creationId="{C76BB371-35F2-FDDD-1F04-EF0162F55102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45" creationId="{5E0644F3-3F7B-EC0C-02E2-DE15BA287915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46" creationId="{8690D77D-EC68-1288-D5A1-6955B2EAA408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52" creationId="{95A4936B-7AB2-EA19-6702-3D7522950095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53" creationId="{45BBF5EA-3ADF-34A8-0306-AE00D1F07FA4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54" creationId="{7CB2228A-FD4A-C7C7-7401-25855BFC0D5D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55" creationId="{45E2C658-80B3-EE95-A357-A17340ED5DDB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56" creationId="{0930AFAA-32A9-51A1-2C38-39200CBAD288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57" creationId="{FF047F85-830E-1ECB-860E-F728C79E22B7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66" creationId="{D4FC9640-326D-00F7-122F-D9DD3B22BFD9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68" creationId="{2B62660C-F2B1-682E-70F2-14FE17DD52AC}"/>
          </ac:picMkLst>
        </pc:picChg>
        <pc:picChg chg="add mod">
          <ac:chgData name="Chiara Napoletano" userId="3382be66-87d3-4f88-8936-a80a8def1550" providerId="ADAL" clId="{22939C8E-67D0-834D-AE47-4396E360C280}" dt="2024-10-23T11:54:42.920" v="44"/>
          <ac:picMkLst>
            <pc:docMk/>
            <pc:sldMk cId="1356691100" sldId="257"/>
            <ac:picMk id="70" creationId="{BF5D88FD-A2E0-64FC-FFF1-943FED861DD2}"/>
          </ac:picMkLst>
        </pc:pic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9" creationId="{D01B0E9B-5E16-DE10-29F6-C1C4B03FA6B0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10" creationId="{E8C97100-5DBA-E757-44A9-AD70AE8EB0F4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16" creationId="{4F219A96-EB12-06BF-9E1F-EBE3EF94AE64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17" creationId="{8E885E96-2047-F34A-7A8F-B11E28E05DC6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18" creationId="{D53A80B6-288F-DC4B-80EB-FD864DC3AE26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27" creationId="{C6FB0329-C2BF-BBAF-FC8F-03589A97A5B8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28" creationId="{DD7931EA-3649-371A-89ED-43A35D40C5CA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29" creationId="{70CA13AD-8943-6724-81AC-094CB2A633DB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30" creationId="{9A32FCDF-5BEB-8C12-B8B6-E795C834CE16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31" creationId="{12625A85-40E5-0906-3327-14F524CAB2B2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32" creationId="{B35C3E41-78D1-52DA-D7C6-8C36B05BDE9D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33" creationId="{5E28FCED-D9BD-6BFA-122F-8B6176F561F2}"/>
          </ac:cxnSpMkLst>
        </pc:cxnChg>
        <pc:cxnChg chg="add del mod">
          <ac:chgData name="Chiara Napoletano" userId="3382be66-87d3-4f88-8936-a80a8def1550" providerId="ADAL" clId="{22939C8E-67D0-834D-AE47-4396E360C280}" dt="2024-10-23T11:54:41.695" v="43" actId="478"/>
          <ac:cxnSpMkLst>
            <pc:docMk/>
            <pc:sldMk cId="1356691100" sldId="257"/>
            <ac:cxnSpMk id="36" creationId="{0E384667-55B5-5D71-60D5-AF6680D1A514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40" creationId="{78665FB3-6824-2717-88E9-A1BA05077906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41" creationId="{E0B83A71-7FA1-8211-8845-EE82E1CCF8D5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47" creationId="{F830DB13-2E31-4DEF-0F6A-46FCFC5CF7C2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48" creationId="{5D37493A-8AD6-816E-F5EB-CA7E3C92248A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49" creationId="{431ABC5A-3A49-8F69-121C-9E8350B36D8E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58" creationId="{81FD2098-8712-C5BD-7AAF-593517437202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59" creationId="{E0D9392D-E905-9BD2-5BAD-380904036947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60" creationId="{D595C161-4E82-037A-DB02-E50F1F050669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61" creationId="{C7F990B2-85FF-91C6-206F-F15D74459E1C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62" creationId="{B579125B-4404-4401-4141-C25A7554C80B}"/>
          </ac:cxnSpMkLst>
        </pc:cxnChg>
        <pc:cxnChg chg="add mod">
          <ac:chgData name="Chiara Napoletano" userId="3382be66-87d3-4f88-8936-a80a8def1550" providerId="ADAL" clId="{22939C8E-67D0-834D-AE47-4396E360C280}" dt="2024-10-23T12:07:51.839" v="392" actId="1076"/>
          <ac:cxnSpMkLst>
            <pc:docMk/>
            <pc:sldMk cId="1356691100" sldId="257"/>
            <ac:cxnSpMk id="63" creationId="{7137D912-A8BE-9925-365D-3C1E0695CD92}"/>
          </ac:cxnSpMkLst>
        </pc:cxnChg>
        <pc:cxnChg chg="add mod">
          <ac:chgData name="Chiara Napoletano" userId="3382be66-87d3-4f88-8936-a80a8def1550" providerId="ADAL" clId="{22939C8E-67D0-834D-AE47-4396E360C280}" dt="2024-10-23T12:07:46.473" v="390" actId="1076"/>
          <ac:cxnSpMkLst>
            <pc:docMk/>
            <pc:sldMk cId="1356691100" sldId="257"/>
            <ac:cxnSpMk id="64" creationId="{E2B56BF4-9DD3-B3CD-6451-5FB29418B5A3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67" creationId="{2B551B02-7750-5357-4AC4-BED62EF94C6E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69" creationId="{B5DB5C75-2E7A-F33F-0C89-FE63EB99D231}"/>
          </ac:cxnSpMkLst>
        </pc:cxnChg>
        <pc:cxnChg chg="add mod">
          <ac:chgData name="Chiara Napoletano" userId="3382be66-87d3-4f88-8936-a80a8def1550" providerId="ADAL" clId="{22939C8E-67D0-834D-AE47-4396E360C280}" dt="2024-10-23T11:54:42.920" v="44"/>
          <ac:cxnSpMkLst>
            <pc:docMk/>
            <pc:sldMk cId="1356691100" sldId="257"/>
            <ac:cxnSpMk id="71" creationId="{F88036B7-A5A5-A3A8-19A4-2BAB3BCC725F}"/>
          </ac:cxnSpMkLst>
        </pc:cxnChg>
      </pc:sldChg>
      <pc:sldChg chg="delSp new del mod">
        <pc:chgData name="Chiara Napoletano" userId="3382be66-87d3-4f88-8936-a80a8def1550" providerId="ADAL" clId="{22939C8E-67D0-834D-AE47-4396E360C280}" dt="2024-10-21T08:48:40.567" v="32" actId="2696"/>
        <pc:sldMkLst>
          <pc:docMk/>
          <pc:sldMk cId="2340614622" sldId="257"/>
        </pc:sldMkLst>
        <pc:spChg chg="del">
          <ac:chgData name="Chiara Napoletano" userId="3382be66-87d3-4f88-8936-a80a8def1550" providerId="ADAL" clId="{22939C8E-67D0-834D-AE47-4396E360C280}" dt="2024-10-21T08:27:25.402" v="30" actId="478"/>
          <ac:spMkLst>
            <pc:docMk/>
            <pc:sldMk cId="2340614622" sldId="257"/>
            <ac:spMk id="2" creationId="{A4FC05EE-2EA6-43AF-4B90-C15F51A7FCF9}"/>
          </ac:spMkLst>
        </pc:spChg>
        <pc:spChg chg="del">
          <ac:chgData name="Chiara Napoletano" userId="3382be66-87d3-4f88-8936-a80a8def1550" providerId="ADAL" clId="{22939C8E-67D0-834D-AE47-4396E360C280}" dt="2024-10-21T08:27:26.873" v="31" actId="478"/>
          <ac:spMkLst>
            <pc:docMk/>
            <pc:sldMk cId="2340614622" sldId="257"/>
            <ac:spMk id="3" creationId="{5223CF19-C53C-EF18-BAC1-CE4E73ECD92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DD17F8-C085-E746-8829-E082B5FCC008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C14C79-48C6-E447-8B98-3A3CF19334E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53212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7C14C79-48C6-E447-8B98-3A3CF19334E8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19297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4980A80-B556-BE5B-F5DE-BD2F37CF35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06FC6B4-A26C-34B0-E718-16B814A3E7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B134C7-CD63-A2DF-A2A9-C6A128547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A13F2D9-AC2A-FC75-65B8-A6147F9F9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172AAF3-E551-ED18-C708-0D012DF7F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9460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6E3F71-DFE6-9033-5957-D6D2F7952C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D2759BA-D125-482C-725C-0CA1227ABC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73EA8A4-D238-FCAD-BBD3-A929EE2C4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F933C2-2EB0-AA99-F209-13FDC50B6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5ACE806-72D7-6C0C-78F9-43425297A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6211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E891DF0-7B5E-7A41-513C-9723D48DF3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A85F6FC-ED8B-E448-BFF0-87173E3DE9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1CB8EE1-D3B1-1936-F4FC-105D2F30D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B80A3E0-7203-5202-AF1F-2F4CADF03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4E6D34-8B74-906C-09CA-3F6C75552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73533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87AA3C4-6533-268D-E1F8-1B965FAE22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165C5F9-B071-EEE7-4DBA-D765F89C98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A220C1F-3264-DB88-6922-19E3F5438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1542D56-40D1-C789-DBFB-E27C3881F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EEB99B0-DE61-5127-D8BB-6406DF138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2230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440E744-FAC8-6360-4F90-28840521CC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2BDF2BC-EB36-B1C7-B19C-D9F2828470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1B0F113-6336-70D8-F25E-95D4F2B22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506B139-1F76-C616-4B9B-A47547C5F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6E7B0F1-07F2-F7B0-A6F6-8B90242A2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1891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6E3DF34-D262-041E-E470-DF8F596735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0A49B8A-0196-7B04-5BBE-31E4F94716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F30003B-6353-5525-5E5E-FF10807B1F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9626D7E-7350-D53A-522F-4EF3DD034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F18C0AE-CC7E-EE8F-4390-47A2FE072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2D43AA9-8045-0512-A293-43164A06A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0805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F0E22F-CD65-0A1D-EA3E-BF115EABE8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C9980AC-1D2F-62F4-2A75-761673564A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872A22F-5468-BFB9-271D-0ADE464664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0CEE317-B2A0-6107-C87C-ED1E7166D7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CE47A8D-19F6-249C-E567-ECAFA16AB1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FBDAA6B0-E38B-B770-6E99-1F2AA072D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DDC9550-76A9-1D59-E4BB-B70FB4DB2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7ADDF6A-7416-0B8B-1423-911495709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6376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2DD4318-D746-F600-BD61-5EBBC441E5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8B3998D-D6D5-B7FD-8680-B9EC647506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F8EFDA2-0C75-1967-1FA1-3BE9AC97B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FF11E08-B22F-6675-092D-D6952B694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1147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CE471C5-09C0-12EE-27D8-44DCC184C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FFC2677-0AD8-2DB8-0BA2-39CDA2367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79266C6E-0685-FF05-6A6D-5F07A7D4C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9497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B4CE0DA-1CFB-CB73-CCE5-D4168BA27D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20E9A42-4609-6330-0394-3E364C3329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8B7C4F0-E8B7-5AB4-134B-D633F994DD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BB45C42-F18F-CC67-263F-FFAE4D01F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E7D8501-EFE7-8720-A44B-81E8E224E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7C375F8-FFF5-E3B1-6E00-BAD78E3C8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1461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ACE1588-59E7-BDDB-A62A-F63A8DDC3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38D9C41-6F1C-5326-773A-8B57B77C5F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79129DD-1C2A-6DB0-3308-D388E7A8A5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0C6340F-3740-74CC-B4B0-905B740FA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1071CE0-8C24-8CBE-B107-8FA06BABC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8AE72AE-04E0-C030-5233-7385EDBBD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9563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067D5DA-2252-3334-724A-D966973E7B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08AF4A0-2D51-1077-408C-BA9FE1F3F0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F13D140-0F8F-9FB1-B27D-DF4AD0487A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46548CC-D932-2D4F-94F3-DCEBE7D65142}" type="datetimeFigureOut">
              <a:rPr lang="it-IT" smtClean="0"/>
              <a:t>24/10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340081-0C7E-D4D4-8BE8-0F36D9B1F1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EAAD025-3B7A-09D6-025E-095D25FBD7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26E8D9-9AD2-A245-A283-76449AB99A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33596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FD5D694E-6B32-5C4C-0615-A949A503807B}"/>
              </a:ext>
            </a:extLst>
          </p:cNvPr>
          <p:cNvSpPr txBox="1"/>
          <p:nvPr/>
        </p:nvSpPr>
        <p:spPr>
          <a:xfrm>
            <a:off x="564859" y="3817386"/>
            <a:ext cx="102338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upplementary Figure 1:  Absolute values of white blood cells (WBCs) and lymphocyte counts obtained from blood exams of cancer patients before (T0)</a:t>
            </a:r>
          </a:p>
          <a:p>
            <a:r>
              <a:rPr lang="en-GB" sz="1200" dirty="0"/>
              <a:t>and after the first cycle of therapy (T1). No significant modulation of WBC and lymphocyte number was observed after the first treatment cycle.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AD67C749-FD70-2C20-64D9-F71D9ACAC5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65700" y="1290086"/>
            <a:ext cx="2260600" cy="2527300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C948334E-D710-356B-DE38-92EEE5A5DE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88593" y="1391686"/>
            <a:ext cx="2336800" cy="2425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100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 descr="Immagine che contiene schermata, Policromia, Rettangolo, quadrato&#10;&#10;Descrizione generata automaticamente">
            <a:extLst>
              <a:ext uri="{FF2B5EF4-FFF2-40B4-BE49-F238E27FC236}">
                <a16:creationId xmlns:a16="http://schemas.microsoft.com/office/drawing/2014/main" id="{4F74472A-002F-D6D6-E551-FCFFB051944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66311" b="68900"/>
          <a:stretch/>
        </p:blipFill>
        <p:spPr>
          <a:xfrm>
            <a:off x="355478" y="69547"/>
            <a:ext cx="1735533" cy="1623920"/>
          </a:xfrm>
          <a:prstGeom prst="rect">
            <a:avLst/>
          </a:prstGeom>
        </p:spPr>
      </p:pic>
      <p:pic>
        <p:nvPicPr>
          <p:cNvPr id="3" name="Immagine 2" descr="Immagine che contiene schermata, Policromia, Rettangolo, quadrato&#10;&#10;Descrizione generata automaticamente">
            <a:extLst>
              <a:ext uri="{FF2B5EF4-FFF2-40B4-BE49-F238E27FC236}">
                <a16:creationId xmlns:a16="http://schemas.microsoft.com/office/drawing/2014/main" id="{48821922-C11B-EB3C-04AB-ADF69C7C8D9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3690" r="32621" b="68900"/>
          <a:stretch/>
        </p:blipFill>
        <p:spPr>
          <a:xfrm>
            <a:off x="2697126" y="79313"/>
            <a:ext cx="1735533" cy="1623920"/>
          </a:xfrm>
          <a:prstGeom prst="rect">
            <a:avLst/>
          </a:prstGeom>
        </p:spPr>
      </p:pic>
      <p:pic>
        <p:nvPicPr>
          <p:cNvPr id="37" name="Immagine 36" descr="Immagine che contiene schermata, Policromia, Rettangolo, quadrato&#10;&#10;Descrizione generata automaticamente">
            <a:extLst>
              <a:ext uri="{FF2B5EF4-FFF2-40B4-BE49-F238E27FC236}">
                <a16:creationId xmlns:a16="http://schemas.microsoft.com/office/drawing/2014/main" id="{35FA0C6D-F0C1-6AA8-300F-D7DFB9D294D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6311" b="68463"/>
          <a:stretch/>
        </p:blipFill>
        <p:spPr>
          <a:xfrm>
            <a:off x="6988485" y="43634"/>
            <a:ext cx="1736005" cy="1647174"/>
          </a:xfrm>
          <a:prstGeom prst="rect">
            <a:avLst/>
          </a:prstGeom>
        </p:spPr>
      </p:pic>
      <p:pic>
        <p:nvPicPr>
          <p:cNvPr id="38" name="Immagine 37" descr="Immagine che contiene schermata, Policromia, Rettangolo, quadrato&#10;&#10;Descrizione generata automaticamente">
            <a:extLst>
              <a:ext uri="{FF2B5EF4-FFF2-40B4-BE49-F238E27FC236}">
                <a16:creationId xmlns:a16="http://schemas.microsoft.com/office/drawing/2014/main" id="{F436D54D-A023-BE17-7654-49853C5EDE8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6302" t="31545" b="36909"/>
          <a:stretch/>
        </p:blipFill>
        <p:spPr>
          <a:xfrm>
            <a:off x="8699327" y="43636"/>
            <a:ext cx="1736005" cy="1647174"/>
          </a:xfrm>
          <a:prstGeom prst="rect">
            <a:avLst/>
          </a:prstGeom>
        </p:spPr>
      </p:pic>
      <p:pic>
        <p:nvPicPr>
          <p:cNvPr id="39" name="Immagine 38" descr="Immagine che contiene schermata, Policromia, Rettangolo, quadrato&#10;&#10;Descrizione generata automaticamente">
            <a:extLst>
              <a:ext uri="{FF2B5EF4-FFF2-40B4-BE49-F238E27FC236}">
                <a16:creationId xmlns:a16="http://schemas.microsoft.com/office/drawing/2014/main" id="{C7EF56DF-144C-E418-63F1-4EF61879371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6302" t="65006"/>
          <a:stretch/>
        </p:blipFill>
        <p:spPr>
          <a:xfrm>
            <a:off x="10435175" y="79313"/>
            <a:ext cx="1736005" cy="1827229"/>
          </a:xfrm>
          <a:prstGeom prst="rect">
            <a:avLst/>
          </a:prstGeom>
        </p:spPr>
      </p:pic>
      <p:cxnSp>
        <p:nvCxnSpPr>
          <p:cNvPr id="40" name="Connettore 2 39">
            <a:extLst>
              <a:ext uri="{FF2B5EF4-FFF2-40B4-BE49-F238E27FC236}">
                <a16:creationId xmlns:a16="http://schemas.microsoft.com/office/drawing/2014/main" id="{78665FB3-6824-2717-88E9-A1BA05077906}"/>
              </a:ext>
            </a:extLst>
          </p:cNvPr>
          <p:cNvCxnSpPr>
            <a:cxnSpLocks/>
          </p:cNvCxnSpPr>
          <p:nvPr/>
        </p:nvCxnSpPr>
        <p:spPr>
          <a:xfrm>
            <a:off x="2178000" y="872814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2 40">
            <a:extLst>
              <a:ext uri="{FF2B5EF4-FFF2-40B4-BE49-F238E27FC236}">
                <a16:creationId xmlns:a16="http://schemas.microsoft.com/office/drawing/2014/main" id="{E0B83A71-7FA1-8211-8845-EE82E1CCF8D5}"/>
              </a:ext>
            </a:extLst>
          </p:cNvPr>
          <p:cNvCxnSpPr>
            <a:cxnSpLocks/>
          </p:cNvCxnSpPr>
          <p:nvPr/>
        </p:nvCxnSpPr>
        <p:spPr>
          <a:xfrm>
            <a:off x="4474161" y="847861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DF28EC33-8D9B-36FB-A14C-66C3F1D91F22}"/>
              </a:ext>
            </a:extLst>
          </p:cNvPr>
          <p:cNvSpPr txBox="1"/>
          <p:nvPr/>
        </p:nvSpPr>
        <p:spPr>
          <a:xfrm>
            <a:off x="92310" y="1603871"/>
            <a:ext cx="39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B.</a:t>
            </a:r>
          </a:p>
        </p:txBody>
      </p:sp>
      <p:pic>
        <p:nvPicPr>
          <p:cNvPr id="43" name="Immagine 42" descr="Immagine che contiene schermata, diagramma, Software multimediale, design&#10;&#10;Descrizione generata automaticamente">
            <a:extLst>
              <a:ext uri="{FF2B5EF4-FFF2-40B4-BE49-F238E27FC236}">
                <a16:creationId xmlns:a16="http://schemas.microsoft.com/office/drawing/2014/main" id="{6D9032C3-75BD-2F09-BD9D-C1A48FDA478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74781"/>
          <a:stretch/>
        </p:blipFill>
        <p:spPr>
          <a:xfrm>
            <a:off x="2388160" y="1906542"/>
            <a:ext cx="1736004" cy="1685058"/>
          </a:xfrm>
          <a:prstGeom prst="rect">
            <a:avLst/>
          </a:prstGeom>
        </p:spPr>
      </p:pic>
      <p:pic>
        <p:nvPicPr>
          <p:cNvPr id="44" name="Immagine 43" descr="Immagine che contiene schermata, diagramma, Software multimediale, design&#10;&#10;Descrizione generata automaticamente">
            <a:extLst>
              <a:ext uri="{FF2B5EF4-FFF2-40B4-BE49-F238E27FC236}">
                <a16:creationId xmlns:a16="http://schemas.microsoft.com/office/drawing/2014/main" id="{C76BB371-35F2-FDDD-1F04-EF0162F5510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5218" r="49563"/>
          <a:stretch/>
        </p:blipFill>
        <p:spPr>
          <a:xfrm>
            <a:off x="6505558" y="1884624"/>
            <a:ext cx="1736005" cy="1685058"/>
          </a:xfrm>
          <a:prstGeom prst="rect">
            <a:avLst/>
          </a:prstGeom>
        </p:spPr>
      </p:pic>
      <p:pic>
        <p:nvPicPr>
          <p:cNvPr id="45" name="Immagine 44" descr="Immagine che contiene schermata, diagramma, Software multimediale, design&#10;&#10;Descrizione generata automaticamente">
            <a:extLst>
              <a:ext uri="{FF2B5EF4-FFF2-40B4-BE49-F238E27FC236}">
                <a16:creationId xmlns:a16="http://schemas.microsoft.com/office/drawing/2014/main" id="{5E0644F3-3F7B-EC0C-02E2-DE15BA287915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0437" r="24344"/>
          <a:stretch/>
        </p:blipFill>
        <p:spPr>
          <a:xfrm>
            <a:off x="8434404" y="1906542"/>
            <a:ext cx="1736005" cy="1685058"/>
          </a:xfrm>
          <a:prstGeom prst="rect">
            <a:avLst/>
          </a:prstGeom>
        </p:spPr>
      </p:pic>
      <p:pic>
        <p:nvPicPr>
          <p:cNvPr id="46" name="Immagine 45" descr="Immagine che contiene schermata, diagramma, Software multimediale, design&#10;&#10;Descrizione generata automaticamente">
            <a:extLst>
              <a:ext uri="{FF2B5EF4-FFF2-40B4-BE49-F238E27FC236}">
                <a16:creationId xmlns:a16="http://schemas.microsoft.com/office/drawing/2014/main" id="{8690D77D-EC68-1288-D5A1-6955B2EAA40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4781"/>
          <a:stretch/>
        </p:blipFill>
        <p:spPr>
          <a:xfrm>
            <a:off x="10409043" y="1846838"/>
            <a:ext cx="1736005" cy="1685058"/>
          </a:xfrm>
          <a:prstGeom prst="rect">
            <a:avLst/>
          </a:prstGeom>
        </p:spPr>
      </p:pic>
      <p:cxnSp>
        <p:nvCxnSpPr>
          <p:cNvPr id="47" name="Connettore 2 46">
            <a:extLst>
              <a:ext uri="{FF2B5EF4-FFF2-40B4-BE49-F238E27FC236}">
                <a16:creationId xmlns:a16="http://schemas.microsoft.com/office/drawing/2014/main" id="{F830DB13-2E31-4DEF-0F6A-46FCFC5CF7C2}"/>
              </a:ext>
            </a:extLst>
          </p:cNvPr>
          <p:cNvCxnSpPr>
            <a:cxnSpLocks/>
          </p:cNvCxnSpPr>
          <p:nvPr/>
        </p:nvCxnSpPr>
        <p:spPr>
          <a:xfrm>
            <a:off x="4175907" y="2559175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ttore 2 47">
            <a:extLst>
              <a:ext uri="{FF2B5EF4-FFF2-40B4-BE49-F238E27FC236}">
                <a16:creationId xmlns:a16="http://schemas.microsoft.com/office/drawing/2014/main" id="{5D37493A-8AD6-816E-F5EB-CA7E3C92248A}"/>
              </a:ext>
            </a:extLst>
          </p:cNvPr>
          <p:cNvCxnSpPr>
            <a:cxnSpLocks/>
          </p:cNvCxnSpPr>
          <p:nvPr/>
        </p:nvCxnSpPr>
        <p:spPr>
          <a:xfrm>
            <a:off x="8121374" y="2555037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ttore 2 48">
            <a:extLst>
              <a:ext uri="{FF2B5EF4-FFF2-40B4-BE49-F238E27FC236}">
                <a16:creationId xmlns:a16="http://schemas.microsoft.com/office/drawing/2014/main" id="{431ABC5A-3A49-8F69-121C-9E8350B36D8E}"/>
              </a:ext>
            </a:extLst>
          </p:cNvPr>
          <p:cNvCxnSpPr>
            <a:cxnSpLocks/>
          </p:cNvCxnSpPr>
          <p:nvPr/>
        </p:nvCxnSpPr>
        <p:spPr>
          <a:xfrm>
            <a:off x="10050812" y="2529698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94908E38-A432-FB11-0070-F7B10EF04B0D}"/>
              </a:ext>
            </a:extLst>
          </p:cNvPr>
          <p:cNvSpPr txBox="1"/>
          <p:nvPr/>
        </p:nvSpPr>
        <p:spPr>
          <a:xfrm>
            <a:off x="5331359" y="3609454"/>
            <a:ext cx="367861" cy="23269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it-IT"/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C336DF86-F080-EC8F-D452-BA33BF8F8F03}"/>
              </a:ext>
            </a:extLst>
          </p:cNvPr>
          <p:cNvSpPr txBox="1"/>
          <p:nvPr/>
        </p:nvSpPr>
        <p:spPr>
          <a:xfrm>
            <a:off x="72112" y="3423391"/>
            <a:ext cx="414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C.</a:t>
            </a:r>
          </a:p>
        </p:txBody>
      </p:sp>
      <p:pic>
        <p:nvPicPr>
          <p:cNvPr id="52" name="Immagine 51" descr="Immagine che contiene schermata&#10;&#10;Descrizione generata automaticamente">
            <a:extLst>
              <a:ext uri="{FF2B5EF4-FFF2-40B4-BE49-F238E27FC236}">
                <a16:creationId xmlns:a16="http://schemas.microsoft.com/office/drawing/2014/main" id="{95A4936B-7AB2-EA19-6702-3D752295009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81423" b="43647"/>
          <a:stretch/>
        </p:blipFill>
        <p:spPr>
          <a:xfrm>
            <a:off x="95956" y="3485104"/>
            <a:ext cx="1998198" cy="1945430"/>
          </a:xfrm>
          <a:prstGeom prst="rect">
            <a:avLst/>
          </a:prstGeom>
        </p:spPr>
      </p:pic>
      <p:pic>
        <p:nvPicPr>
          <p:cNvPr id="53" name="Immagine 52" descr="Immagine che contiene schermata&#10;&#10;Descrizione generata automaticamente">
            <a:extLst>
              <a:ext uri="{FF2B5EF4-FFF2-40B4-BE49-F238E27FC236}">
                <a16:creationId xmlns:a16="http://schemas.microsoft.com/office/drawing/2014/main" id="{45BBF5EA-3ADF-34A8-0306-AE00D1F07FA4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8576" r="65802" b="43647"/>
          <a:stretch/>
        </p:blipFill>
        <p:spPr>
          <a:xfrm>
            <a:off x="2405133" y="3454802"/>
            <a:ext cx="1680329" cy="1945430"/>
          </a:xfrm>
          <a:prstGeom prst="rect">
            <a:avLst/>
          </a:prstGeom>
        </p:spPr>
      </p:pic>
      <p:pic>
        <p:nvPicPr>
          <p:cNvPr id="54" name="Immagine 53" descr="Immagine che contiene schermata&#10;&#10;Descrizione generata automaticamente">
            <a:extLst>
              <a:ext uri="{FF2B5EF4-FFF2-40B4-BE49-F238E27FC236}">
                <a16:creationId xmlns:a16="http://schemas.microsoft.com/office/drawing/2014/main" id="{7CB2228A-FD4A-C7C7-7401-25855BFC0D5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4198" r="50180" b="44393"/>
          <a:stretch/>
        </p:blipFill>
        <p:spPr>
          <a:xfrm>
            <a:off x="4410993" y="3472274"/>
            <a:ext cx="1680329" cy="1919711"/>
          </a:xfrm>
          <a:prstGeom prst="rect">
            <a:avLst/>
          </a:prstGeom>
        </p:spPr>
      </p:pic>
      <p:pic>
        <p:nvPicPr>
          <p:cNvPr id="55" name="Immagine 54" descr="Immagine che contiene schermata&#10;&#10;Descrizione generata automaticamente">
            <a:extLst>
              <a:ext uri="{FF2B5EF4-FFF2-40B4-BE49-F238E27FC236}">
                <a16:creationId xmlns:a16="http://schemas.microsoft.com/office/drawing/2014/main" id="{45E2C658-80B3-EE95-A357-A17340ED5DD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49819" r="34760" b="43767"/>
          <a:stretch/>
        </p:blipFill>
        <p:spPr>
          <a:xfrm>
            <a:off x="6512411" y="3538728"/>
            <a:ext cx="1658787" cy="1941306"/>
          </a:xfrm>
          <a:prstGeom prst="rect">
            <a:avLst/>
          </a:prstGeom>
        </p:spPr>
      </p:pic>
      <p:pic>
        <p:nvPicPr>
          <p:cNvPr id="56" name="Immagine 55" descr="Immagine che contiene schermata&#10;&#10;Descrizione generata automaticamente">
            <a:extLst>
              <a:ext uri="{FF2B5EF4-FFF2-40B4-BE49-F238E27FC236}">
                <a16:creationId xmlns:a16="http://schemas.microsoft.com/office/drawing/2014/main" id="{0930AFAA-32A9-51A1-2C38-39200CBAD28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5241" r="17408"/>
          <a:stretch/>
        </p:blipFill>
        <p:spPr>
          <a:xfrm>
            <a:off x="8296461" y="3423390"/>
            <a:ext cx="1866378" cy="3452245"/>
          </a:xfrm>
          <a:prstGeom prst="rect">
            <a:avLst/>
          </a:prstGeom>
        </p:spPr>
      </p:pic>
      <p:pic>
        <p:nvPicPr>
          <p:cNvPr id="57" name="Immagine 56" descr="Immagine che contiene schermata&#10;&#10;Descrizione generata automaticamente">
            <a:extLst>
              <a:ext uri="{FF2B5EF4-FFF2-40B4-BE49-F238E27FC236}">
                <a16:creationId xmlns:a16="http://schemas.microsoft.com/office/drawing/2014/main" id="{FF047F85-830E-1ECB-860E-F728C79E22B7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82649"/>
          <a:stretch/>
        </p:blipFill>
        <p:spPr>
          <a:xfrm>
            <a:off x="10249954" y="3423391"/>
            <a:ext cx="1866378" cy="3452245"/>
          </a:xfrm>
          <a:prstGeom prst="rect">
            <a:avLst/>
          </a:prstGeom>
        </p:spPr>
      </p:pic>
      <p:cxnSp>
        <p:nvCxnSpPr>
          <p:cNvPr id="58" name="Connettore 2 57">
            <a:extLst>
              <a:ext uri="{FF2B5EF4-FFF2-40B4-BE49-F238E27FC236}">
                <a16:creationId xmlns:a16="http://schemas.microsoft.com/office/drawing/2014/main" id="{81FD2098-8712-C5BD-7AAF-593517437202}"/>
              </a:ext>
            </a:extLst>
          </p:cNvPr>
          <p:cNvCxnSpPr>
            <a:cxnSpLocks/>
          </p:cNvCxnSpPr>
          <p:nvPr/>
        </p:nvCxnSpPr>
        <p:spPr>
          <a:xfrm>
            <a:off x="2029161" y="4471043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nettore 2 58">
            <a:extLst>
              <a:ext uri="{FF2B5EF4-FFF2-40B4-BE49-F238E27FC236}">
                <a16:creationId xmlns:a16="http://schemas.microsoft.com/office/drawing/2014/main" id="{E0D9392D-E905-9BD2-5BAD-380904036947}"/>
              </a:ext>
            </a:extLst>
          </p:cNvPr>
          <p:cNvCxnSpPr>
            <a:cxnSpLocks/>
          </p:cNvCxnSpPr>
          <p:nvPr/>
        </p:nvCxnSpPr>
        <p:spPr>
          <a:xfrm>
            <a:off x="4036090" y="4475167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nettore 2 59">
            <a:extLst>
              <a:ext uri="{FF2B5EF4-FFF2-40B4-BE49-F238E27FC236}">
                <a16:creationId xmlns:a16="http://schemas.microsoft.com/office/drawing/2014/main" id="{D595C161-4E82-037A-DB02-E50F1F050669}"/>
              </a:ext>
            </a:extLst>
          </p:cNvPr>
          <p:cNvCxnSpPr>
            <a:cxnSpLocks/>
          </p:cNvCxnSpPr>
          <p:nvPr/>
        </p:nvCxnSpPr>
        <p:spPr>
          <a:xfrm>
            <a:off x="6092441" y="4483869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ttore 2 60">
            <a:extLst>
              <a:ext uri="{FF2B5EF4-FFF2-40B4-BE49-F238E27FC236}">
                <a16:creationId xmlns:a16="http://schemas.microsoft.com/office/drawing/2014/main" id="{C7F990B2-85FF-91C6-206F-F15D74459E1C}"/>
              </a:ext>
            </a:extLst>
          </p:cNvPr>
          <p:cNvCxnSpPr>
            <a:cxnSpLocks/>
          </p:cNvCxnSpPr>
          <p:nvPr/>
        </p:nvCxnSpPr>
        <p:spPr>
          <a:xfrm>
            <a:off x="9981915" y="4109403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ttore 2 61">
            <a:extLst>
              <a:ext uri="{FF2B5EF4-FFF2-40B4-BE49-F238E27FC236}">
                <a16:creationId xmlns:a16="http://schemas.microsoft.com/office/drawing/2014/main" id="{B579125B-4404-4401-4141-C25A7554C80B}"/>
              </a:ext>
            </a:extLst>
          </p:cNvPr>
          <p:cNvCxnSpPr>
            <a:cxnSpLocks/>
          </p:cNvCxnSpPr>
          <p:nvPr/>
        </p:nvCxnSpPr>
        <p:spPr>
          <a:xfrm>
            <a:off x="10050812" y="5803675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ttore 2 62">
            <a:extLst>
              <a:ext uri="{FF2B5EF4-FFF2-40B4-BE49-F238E27FC236}">
                <a16:creationId xmlns:a16="http://schemas.microsoft.com/office/drawing/2014/main" id="{7137D912-A8BE-9925-365D-3C1E0695CD92}"/>
              </a:ext>
            </a:extLst>
          </p:cNvPr>
          <p:cNvCxnSpPr>
            <a:cxnSpLocks/>
          </p:cNvCxnSpPr>
          <p:nvPr/>
        </p:nvCxnSpPr>
        <p:spPr>
          <a:xfrm>
            <a:off x="8079144" y="4465614"/>
            <a:ext cx="379736" cy="30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ttore 2 63">
            <a:extLst>
              <a:ext uri="{FF2B5EF4-FFF2-40B4-BE49-F238E27FC236}">
                <a16:creationId xmlns:a16="http://schemas.microsoft.com/office/drawing/2014/main" id="{E2B56BF4-9DD3-B3CD-6451-5FB29418B5A3}"/>
              </a:ext>
            </a:extLst>
          </p:cNvPr>
          <p:cNvCxnSpPr>
            <a:cxnSpLocks/>
          </p:cNvCxnSpPr>
          <p:nvPr/>
        </p:nvCxnSpPr>
        <p:spPr>
          <a:xfrm>
            <a:off x="7814033" y="5285933"/>
            <a:ext cx="378150" cy="2121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0F80D3FA-0E68-0F64-0458-98BD87AA15D0}"/>
              </a:ext>
            </a:extLst>
          </p:cNvPr>
          <p:cNvSpPr txBox="1"/>
          <p:nvPr/>
        </p:nvSpPr>
        <p:spPr>
          <a:xfrm>
            <a:off x="45554" y="97017"/>
            <a:ext cx="400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A.</a:t>
            </a:r>
          </a:p>
        </p:txBody>
      </p:sp>
      <p:pic>
        <p:nvPicPr>
          <p:cNvPr id="66" name="Immagine 65" descr="Immagine che contiene schermata, Elementi grafici, Policromia, Software multimediale&#10;&#10;Descrizione generata automaticamente">
            <a:extLst>
              <a:ext uri="{FF2B5EF4-FFF2-40B4-BE49-F238E27FC236}">
                <a16:creationId xmlns:a16="http://schemas.microsoft.com/office/drawing/2014/main" id="{D4FC9640-326D-00F7-122F-D9DD3B22BFD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46175" r="73162" b="4190"/>
          <a:stretch/>
        </p:blipFill>
        <p:spPr>
          <a:xfrm>
            <a:off x="328324" y="1827692"/>
            <a:ext cx="1875563" cy="1734404"/>
          </a:xfrm>
          <a:prstGeom prst="rect">
            <a:avLst/>
          </a:prstGeom>
        </p:spPr>
      </p:pic>
      <p:cxnSp>
        <p:nvCxnSpPr>
          <p:cNvPr id="67" name="Connettore 2 66">
            <a:extLst>
              <a:ext uri="{FF2B5EF4-FFF2-40B4-BE49-F238E27FC236}">
                <a16:creationId xmlns:a16="http://schemas.microsoft.com/office/drawing/2014/main" id="{2B551B02-7750-5357-4AC4-BED62EF94C6E}"/>
              </a:ext>
            </a:extLst>
          </p:cNvPr>
          <p:cNvCxnSpPr>
            <a:cxnSpLocks/>
          </p:cNvCxnSpPr>
          <p:nvPr/>
        </p:nvCxnSpPr>
        <p:spPr>
          <a:xfrm>
            <a:off x="2099834" y="2557821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8" name="Immagine 67" descr="Immagine che contiene testo, mappa, schermata, diagramma&#10;&#10;Descrizione generata automaticamente">
            <a:extLst>
              <a:ext uri="{FF2B5EF4-FFF2-40B4-BE49-F238E27FC236}">
                <a16:creationId xmlns:a16="http://schemas.microsoft.com/office/drawing/2014/main" id="{2B62660C-F2B1-682E-70F2-14FE17DD52AC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r="49901" b="25311"/>
          <a:stretch/>
        </p:blipFill>
        <p:spPr>
          <a:xfrm>
            <a:off x="4675516" y="101178"/>
            <a:ext cx="1802296" cy="1567363"/>
          </a:xfrm>
          <a:prstGeom prst="rect">
            <a:avLst/>
          </a:prstGeom>
        </p:spPr>
      </p:pic>
      <p:cxnSp>
        <p:nvCxnSpPr>
          <p:cNvPr id="69" name="Connettore 2 68">
            <a:extLst>
              <a:ext uri="{FF2B5EF4-FFF2-40B4-BE49-F238E27FC236}">
                <a16:creationId xmlns:a16="http://schemas.microsoft.com/office/drawing/2014/main" id="{B5DB5C75-2E7A-F33F-0C89-FE63EB99D231}"/>
              </a:ext>
            </a:extLst>
          </p:cNvPr>
          <p:cNvCxnSpPr>
            <a:cxnSpLocks/>
          </p:cNvCxnSpPr>
          <p:nvPr/>
        </p:nvCxnSpPr>
        <p:spPr>
          <a:xfrm>
            <a:off x="6516823" y="843737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0" name="Immagine 69" descr="Immagine che contiene testo, mappa, schermata, diagramma&#10;&#10;Descrizione generata automaticamente">
            <a:extLst>
              <a:ext uri="{FF2B5EF4-FFF2-40B4-BE49-F238E27FC236}">
                <a16:creationId xmlns:a16="http://schemas.microsoft.com/office/drawing/2014/main" id="{BF5D88FD-A2E0-64FC-FFF1-943FED861DD2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53635" b="24525"/>
          <a:stretch/>
        </p:blipFill>
        <p:spPr>
          <a:xfrm>
            <a:off x="4543303" y="1936713"/>
            <a:ext cx="1619148" cy="1537497"/>
          </a:xfrm>
          <a:prstGeom prst="rect">
            <a:avLst/>
          </a:prstGeom>
        </p:spPr>
      </p:pic>
      <p:cxnSp>
        <p:nvCxnSpPr>
          <p:cNvPr id="71" name="Connettore 2 70">
            <a:extLst>
              <a:ext uri="{FF2B5EF4-FFF2-40B4-BE49-F238E27FC236}">
                <a16:creationId xmlns:a16="http://schemas.microsoft.com/office/drawing/2014/main" id="{F88036B7-A5A5-A3A8-19A4-2BAB3BCC725F}"/>
              </a:ext>
            </a:extLst>
          </p:cNvPr>
          <p:cNvCxnSpPr>
            <a:cxnSpLocks/>
          </p:cNvCxnSpPr>
          <p:nvPr/>
        </p:nvCxnSpPr>
        <p:spPr>
          <a:xfrm>
            <a:off x="6142261" y="2529698"/>
            <a:ext cx="413352" cy="4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583A0904-A723-369E-DE80-BEC69EB50B7D}"/>
              </a:ext>
            </a:extLst>
          </p:cNvPr>
          <p:cNvSpPr txBox="1"/>
          <p:nvPr/>
        </p:nvSpPr>
        <p:spPr>
          <a:xfrm>
            <a:off x="217244" y="5424257"/>
            <a:ext cx="8444941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2: Gating strategies. A</a:t>
            </a:r>
            <a:r>
              <a:rPr lang="en-US" sz="10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Identification of activating and proliferating lymphocytes. L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ymphocytes were selected by gating on </a:t>
            </a:r>
          </a:p>
          <a:p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SC-A/SSC-A, SSC-A/CD3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and live cells/CD3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Ten thousand live cells/CD3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vents were acquired and analyzed as CD137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D1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nd Ki67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+</a:t>
            </a:r>
            <a:r>
              <a:rPr lang="en-US" sz="10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T cells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</a:p>
          <a:p>
            <a:r>
              <a:rPr lang="en-US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dentification of Tregs. Tregs were evaluated by gating on FSC-A/SSC-A, SSC-A/CD3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live cells/CD3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and SSC-A/CD4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.  Twenty thousand </a:t>
            </a:r>
          </a:p>
          <a:p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SC-A/CD4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 were acquired. Tregs were identified as CD4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25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xP3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Treg subpopulations were studied using the CD45RA marker as </a:t>
            </a:r>
          </a:p>
          <a:p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ctive (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25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igh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xp3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igh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45RA</a:t>
            </a:r>
            <a:r>
              <a:rPr lang="en-US" sz="10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resting (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25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xp3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ow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45RA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and non-suppressive (CD4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25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ow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xp3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ow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45RA</a:t>
            </a:r>
            <a:r>
              <a:rPr lang="en-US" sz="10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Tregs.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</a:p>
          <a:p>
            <a:r>
              <a:rPr lang="en-US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.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DSCs were selected by gating all events, except debris, using FSC-A/SSC-A parameters, followed by live cells/FSC-A and SSC-A/CD45RA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</a:p>
          <a:p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ox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MN-MDSCs were selected as SSC-A/CD66b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, HLA-DR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 CD66b 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 and CD66b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Lox1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M-MDSCs were recognized among CD66b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, </a:t>
            </a:r>
          </a:p>
          <a:p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SC-A/CD14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,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 CD14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HLA-DR</a:t>
            </a:r>
            <a:r>
              <a:rPr lang="en-US" sz="10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-</a:t>
            </a:r>
            <a:r>
              <a:rPr lang="en-US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. </a:t>
            </a:r>
          </a:p>
        </p:txBody>
      </p:sp>
    </p:spTree>
    <p:extLst>
      <p:ext uri="{BB962C8B-B14F-4D97-AF65-F5344CB8AC3E}">
        <p14:creationId xmlns:p14="http://schemas.microsoft.com/office/powerpoint/2010/main" val="13566911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</TotalTime>
  <Words>273</Words>
  <Application>Microsoft Macintosh PowerPoint</Application>
  <PresentationFormat>Widescreen</PresentationFormat>
  <Paragraphs>14</Paragraphs>
  <Slides>2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iara Napoletano</dc:creator>
  <cp:lastModifiedBy>Chiara Napoletano</cp:lastModifiedBy>
  <cp:revision>2</cp:revision>
  <dcterms:created xsi:type="dcterms:W3CDTF">2024-10-16T08:35:39Z</dcterms:created>
  <dcterms:modified xsi:type="dcterms:W3CDTF">2024-10-24T12:16:53Z</dcterms:modified>
</cp:coreProperties>
</file>